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280"/>
    <p:restoredTop sz="94720"/>
  </p:normalViewPr>
  <p:slideViewPr>
    <p:cSldViewPr snapToGrid="0">
      <p:cViewPr varScale="1">
        <p:scale>
          <a:sx n="215" d="100"/>
          <a:sy n="215" d="100"/>
        </p:scale>
        <p:origin x="332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0B86A75-AAEC-2FC9-7B10-1EA81C6AA69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BDC4C3DA-E69E-28F7-8745-12340BA5914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9082CA1-D8E0-47B7-E046-D5C10B702F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A2D2C-D92A-1A46-B89E-D0DE79E4E7F1}" type="datetimeFigureOut">
              <a:rPr kumimoji="1" lang="ja-JP" altLang="en-US" smtClean="0"/>
              <a:t>2023/5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E318EA2-C3A1-4401-7FAD-7844E6249E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6CA8BAF-D830-D105-F821-CCA4FC99E7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3036C-0E74-3F45-8B83-7F98870632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8794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89CA7F2-9EB2-DEAD-9302-75911E5559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2BDA057-4E40-2703-12C6-130BF0A69E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BE9B2AA-7427-F7C2-D6F1-39399341A5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A2D2C-D92A-1A46-B89E-D0DE79E4E7F1}" type="datetimeFigureOut">
              <a:rPr kumimoji="1" lang="ja-JP" altLang="en-US" smtClean="0"/>
              <a:t>2023/5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B4F6AEA-4751-73A5-DF65-7C015925B8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9489C84-D0A1-9DB3-361A-D8FDD6E430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3036C-0E74-3F45-8B83-7F98870632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40991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0DB47060-135A-7E1E-1828-125851B2004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473658A-CB6A-1EB6-84AA-8ED2A739E2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C67C74B-A9D9-1BC1-0E1A-3DBF46F2DF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A2D2C-D92A-1A46-B89E-D0DE79E4E7F1}" type="datetimeFigureOut">
              <a:rPr kumimoji="1" lang="ja-JP" altLang="en-US" smtClean="0"/>
              <a:t>2023/5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8F719C3-AADD-E268-B429-6F59988E6C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2EF7DD9-0757-C28F-618B-16CB76E9FB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3036C-0E74-3F45-8B83-7F98870632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02314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AA341B3-1A70-71CB-76DE-C40F167AB3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E4D676D-87C6-ABE3-F82A-B29A8C83163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03834EB-1FFD-0428-6F51-29916D0CAA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A2D2C-D92A-1A46-B89E-D0DE79E4E7F1}" type="datetimeFigureOut">
              <a:rPr kumimoji="1" lang="ja-JP" altLang="en-US" smtClean="0"/>
              <a:t>2023/5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DD6DBD5-DF73-1EC2-9CF4-B99516FF35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FEE0EB2-1DBA-779B-F405-4127EE3B92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3036C-0E74-3F45-8B83-7F98870632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21560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CCAEFA8-CABB-48EA-67B7-AAE8B7F7F7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B57B05F-0C20-C044-1D97-3080593D15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BCA9D97-CEF9-0C6C-F468-A80688067B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A2D2C-D92A-1A46-B89E-D0DE79E4E7F1}" type="datetimeFigureOut">
              <a:rPr kumimoji="1" lang="ja-JP" altLang="en-US" smtClean="0"/>
              <a:t>2023/5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33490AE-4694-E4EA-1F8C-D1F6415450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3CA714D-81D3-7DEF-4D6A-DF917DF909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3036C-0E74-3F45-8B83-7F98870632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27094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C656FCC-EE64-3C09-5B87-2131216E60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E7197FE-C152-0CDD-309F-8E9A767AA8D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1732238-66D6-6672-E670-C1A3811DA4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608B433-4B3E-8E33-7799-77CF93CFDF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A2D2C-D92A-1A46-B89E-D0DE79E4E7F1}" type="datetimeFigureOut">
              <a:rPr kumimoji="1" lang="ja-JP" altLang="en-US" smtClean="0"/>
              <a:t>2023/5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ED35548-49D7-2FAE-2BEE-AAE8FE3294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BD2C636-381E-1524-108A-FFCF0D1459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3036C-0E74-3F45-8B83-7F98870632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4555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06A554E-D158-41D5-B68F-A35BC7A123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AD380D0-040D-0568-5580-6AEB7A0CC7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FACAF6B-72EB-86A8-DD9D-FB0A7EDE33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F5AD234-0117-1707-128E-86C5DDE174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806D599-6153-131E-9A3E-293B3D51F53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7615C4CE-0999-6CE0-46A6-476012536C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A2D2C-D92A-1A46-B89E-D0DE79E4E7F1}" type="datetimeFigureOut">
              <a:rPr kumimoji="1" lang="ja-JP" altLang="en-US" smtClean="0"/>
              <a:t>2023/5/3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B3E2734-1EC8-7B61-4652-59EFD11C97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35D25873-86F3-FE9A-4168-B7646AE3FE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3036C-0E74-3F45-8B83-7F98870632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0369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5AE52AC-A35F-01F0-FD4E-6C7FE1290E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0120B4B5-8FAF-232D-5420-890F030E15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A2D2C-D92A-1A46-B89E-D0DE79E4E7F1}" type="datetimeFigureOut">
              <a:rPr kumimoji="1" lang="ja-JP" altLang="en-US" smtClean="0"/>
              <a:t>2023/5/3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7F395537-887A-A435-97D2-E616047917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DC16F1C-D48E-E7F7-74F7-2045DF3018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3036C-0E74-3F45-8B83-7F98870632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85145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3A5EC32-A793-DB10-8D2A-A4E2D12D90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A2D2C-D92A-1A46-B89E-D0DE79E4E7F1}" type="datetimeFigureOut">
              <a:rPr kumimoji="1" lang="ja-JP" altLang="en-US" smtClean="0"/>
              <a:t>2023/5/3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0B68BC0-9AC2-FE61-2FD0-008878AC8E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ABD6201-D26F-5628-1F5E-094D5B7BFF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3036C-0E74-3F45-8B83-7F98870632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93715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9C4C384-CC41-882F-40E9-8FF7299EAB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C0AC49C-2A28-F47C-577F-AD9E8C6081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ADB58EA-E4FD-02C2-BFC9-9AF73D3590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560150B-8B51-0B00-F5CF-167B8E85E0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A2D2C-D92A-1A46-B89E-D0DE79E4E7F1}" type="datetimeFigureOut">
              <a:rPr kumimoji="1" lang="ja-JP" altLang="en-US" smtClean="0"/>
              <a:t>2023/5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C99245A-4670-97EB-8672-39855E3CC5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684CB4B-8E10-3F7E-0279-7EF4E72404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3036C-0E74-3F45-8B83-7F98870632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886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B038013-7936-002D-6D5F-DB5C83E7BC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14EA8D9-5B85-0D4A-6CDB-8D85B9B6A42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336A212-F701-D7D1-7474-C2ED8E951F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3329EC6-75DD-D8AA-F61A-AFA0854626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A2D2C-D92A-1A46-B89E-D0DE79E4E7F1}" type="datetimeFigureOut">
              <a:rPr kumimoji="1" lang="ja-JP" altLang="en-US" smtClean="0"/>
              <a:t>2023/5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6D40CB7-34DD-A3AA-F78B-D8CA4823C5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F85E600-8E29-00A1-9AEF-7B61200777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3036C-0E74-3F45-8B83-7F98870632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99503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64136F5F-5F8E-E87D-5B8F-7495F63280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2864CB7-87CA-CC2E-2E90-9C74F8C21F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5264B6A-E608-E8CE-9E30-AC318195FE0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CA2D2C-D92A-1A46-B89E-D0DE79E4E7F1}" type="datetimeFigureOut">
              <a:rPr kumimoji="1" lang="ja-JP" altLang="en-US" smtClean="0"/>
              <a:t>2023/5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EBA0BC3-F902-74DB-FE5E-9BCDCEF6621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5B18A14-828D-15EF-BF76-F589FE0FA57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23036C-0E74-3F45-8B83-7F98870632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18405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>
            <a:extLst>
              <a:ext uri="{FF2B5EF4-FFF2-40B4-BE49-F238E27FC236}">
                <a16:creationId xmlns:a16="http://schemas.microsoft.com/office/drawing/2014/main" id="{230111DF-C135-2C2E-3DF6-143D3126C30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242" t="16523" r="6954" b="2242"/>
          <a:stretch/>
        </p:blipFill>
        <p:spPr>
          <a:xfrm>
            <a:off x="6921770" y="445230"/>
            <a:ext cx="4916046" cy="5199602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021E4092-2CDE-A999-9043-AC613BCEB68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5347" t="16368" r="7093" b="1906"/>
          <a:stretch/>
        </p:blipFill>
        <p:spPr>
          <a:xfrm>
            <a:off x="925954" y="413752"/>
            <a:ext cx="4964442" cy="5231080"/>
          </a:xfrm>
          <a:prstGeom prst="rect">
            <a:avLst/>
          </a:prstGeom>
        </p:spPr>
      </p:pic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30E1A7D9-5396-03B9-7CE6-1A0F0BD60E84}"/>
              </a:ext>
            </a:extLst>
          </p:cNvPr>
          <p:cNvSpPr/>
          <p:nvPr/>
        </p:nvSpPr>
        <p:spPr>
          <a:xfrm>
            <a:off x="9621426" y="957755"/>
            <a:ext cx="2103066" cy="88357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D3970CD2-0320-1259-EA7E-8FF0D52A10EB}"/>
              </a:ext>
            </a:extLst>
          </p:cNvPr>
          <p:cNvSpPr txBox="1"/>
          <p:nvPr/>
        </p:nvSpPr>
        <p:spPr>
          <a:xfrm>
            <a:off x="9902773" y="2417118"/>
            <a:ext cx="26444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RTp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ld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65)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C1B0F474-4A67-0FBF-E146-02ED8E266E82}"/>
              </a:ext>
            </a:extLst>
          </p:cNvPr>
          <p:cNvSpPr txBox="1"/>
          <p:nvPr/>
        </p:nvSpPr>
        <p:spPr>
          <a:xfrm>
            <a:off x="7888053" y="3008573"/>
            <a:ext cx="19323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i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ERTp</a:t>
            </a:r>
            <a:r>
              <a:rPr lang="en-US" altLang="ja-JP" sz="1400" i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ut (n=143)</a:t>
            </a:r>
            <a:endParaRPr kumimoji="1" lang="ja-JP" altLang="en-US" sz="140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C6216A7A-77E0-B2B7-852A-A93024ABD235}"/>
              </a:ext>
            </a:extLst>
          </p:cNvPr>
          <p:cNvSpPr/>
          <p:nvPr/>
        </p:nvSpPr>
        <p:spPr>
          <a:xfrm>
            <a:off x="8561411" y="84264"/>
            <a:ext cx="1668483" cy="73448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E5D2730D-DEA5-4C7F-B909-E6381CF02069}"/>
              </a:ext>
            </a:extLst>
          </p:cNvPr>
          <p:cNvSpPr txBox="1"/>
          <p:nvPr/>
        </p:nvSpPr>
        <p:spPr>
          <a:xfrm rot="16200000">
            <a:off x="-297579" y="1333923"/>
            <a:ext cx="22643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ability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754F9C48-285B-CFB3-CAD5-8B0C1427F07D}"/>
              </a:ext>
            </a:extLst>
          </p:cNvPr>
          <p:cNvSpPr/>
          <p:nvPr/>
        </p:nvSpPr>
        <p:spPr>
          <a:xfrm>
            <a:off x="4207562" y="952659"/>
            <a:ext cx="1668483" cy="87626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7CF02811-1012-C5AB-80B8-906619013C15}"/>
              </a:ext>
            </a:extLst>
          </p:cNvPr>
          <p:cNvSpPr txBox="1"/>
          <p:nvPr/>
        </p:nvSpPr>
        <p:spPr>
          <a:xfrm>
            <a:off x="3183032" y="919792"/>
            <a:ext cx="271054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R: 1.14 (95% CI: 0.79-1.64)</a:t>
            </a:r>
          </a:p>
          <a:p>
            <a:r>
              <a:rPr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p=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81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7F434904-A25C-06EB-894D-378CB933BECF}"/>
              </a:ext>
            </a:extLst>
          </p:cNvPr>
          <p:cNvSpPr txBox="1"/>
          <p:nvPr/>
        </p:nvSpPr>
        <p:spPr>
          <a:xfrm>
            <a:off x="289544" y="229367"/>
            <a:ext cx="5241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ECF70E39-E0D3-24B4-72F9-E0B2FC9ABF35}"/>
              </a:ext>
            </a:extLst>
          </p:cNvPr>
          <p:cNvSpPr txBox="1"/>
          <p:nvPr/>
        </p:nvSpPr>
        <p:spPr>
          <a:xfrm>
            <a:off x="5775590" y="229367"/>
            <a:ext cx="5241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28811F7-937B-70BC-84D8-3E39CFA1A3AF}"/>
              </a:ext>
            </a:extLst>
          </p:cNvPr>
          <p:cNvSpPr txBox="1"/>
          <p:nvPr/>
        </p:nvSpPr>
        <p:spPr>
          <a:xfrm>
            <a:off x="3567845" y="2725759"/>
            <a:ext cx="26444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RTp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ld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65)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8F722657-D2AB-91D8-6FB0-5D29ED616F44}"/>
              </a:ext>
            </a:extLst>
          </p:cNvPr>
          <p:cNvSpPr txBox="1"/>
          <p:nvPr/>
        </p:nvSpPr>
        <p:spPr>
          <a:xfrm>
            <a:off x="1635511" y="2854685"/>
            <a:ext cx="19323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i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ERTp</a:t>
            </a:r>
            <a:r>
              <a:rPr lang="en-US" altLang="ja-JP" sz="1400" i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ut (n=143)</a:t>
            </a:r>
            <a:endParaRPr kumimoji="1" lang="ja-JP" altLang="en-US" sz="140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FC0CB10-9763-8AB7-3A27-557BC2D7A5B2}"/>
              </a:ext>
            </a:extLst>
          </p:cNvPr>
          <p:cNvSpPr txBox="1"/>
          <p:nvPr/>
        </p:nvSpPr>
        <p:spPr>
          <a:xfrm>
            <a:off x="813651" y="5837264"/>
            <a:ext cx="10757033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6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1 </a:t>
            </a:r>
            <a:r>
              <a:rPr lang="en-US" altLang="ja-JP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rogression-free survival (PFS) and overall survival (OS) analysis of patients with </a:t>
            </a:r>
            <a:r>
              <a:rPr lang="en-US" altLang="ja-JP" sz="16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DH</a:t>
            </a:r>
            <a:r>
              <a:rPr lang="en-US" altLang="ja-JP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-wildtype glioblastoma according to </a:t>
            </a:r>
            <a:r>
              <a:rPr lang="en-US" altLang="ja-JP" sz="160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ERTp</a:t>
            </a:r>
            <a:r>
              <a:rPr lang="en-US" altLang="ja-JP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status. (A) PFS analysis of patients with and without </a:t>
            </a:r>
            <a:r>
              <a:rPr lang="en-US" altLang="ja-JP" sz="160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ERTp</a:t>
            </a:r>
            <a:r>
              <a:rPr lang="en-US" altLang="ja-JP" sz="16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mutations</a:t>
            </a:r>
            <a:r>
              <a:rPr lang="en-US" altLang="ja-JP" sz="16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in </a:t>
            </a:r>
            <a:r>
              <a:rPr lang="en-US" altLang="ja-JP" sz="16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DH-</a:t>
            </a:r>
            <a:r>
              <a:rPr lang="en-US" altLang="ja-JP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ldtype glioblastomas</a:t>
            </a:r>
            <a:r>
              <a:rPr lang="en-US" altLang="ja-JP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 (B) OS analysis of patients with and without </a:t>
            </a:r>
            <a:r>
              <a:rPr lang="en-US" altLang="ja-JP" sz="160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ERTp</a:t>
            </a:r>
            <a:r>
              <a:rPr lang="en-US" altLang="ja-JP" sz="16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mutations</a:t>
            </a:r>
            <a:r>
              <a:rPr lang="en-US" altLang="ja-JP" sz="16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in </a:t>
            </a:r>
            <a:r>
              <a:rPr lang="en-US" altLang="ja-JP" sz="16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DH-</a:t>
            </a:r>
            <a:r>
              <a:rPr lang="en-US" altLang="ja-JP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ldtype glioblastomas</a:t>
            </a:r>
            <a:r>
              <a:rPr lang="en-US" altLang="ja-JP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</a:t>
            </a:r>
            <a:endParaRPr lang="ja-JP" altLang="ja-JP" sz="1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1F37CE2D-8905-66BE-13A7-C3F53F73C577}"/>
              </a:ext>
            </a:extLst>
          </p:cNvPr>
          <p:cNvSpPr/>
          <p:nvPr/>
        </p:nvSpPr>
        <p:spPr>
          <a:xfrm>
            <a:off x="2933205" y="4281375"/>
            <a:ext cx="1537855" cy="38562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FDB5DE0C-BE81-ED30-6ED4-52B62A87B913}"/>
              </a:ext>
            </a:extLst>
          </p:cNvPr>
          <p:cNvSpPr/>
          <p:nvPr/>
        </p:nvSpPr>
        <p:spPr>
          <a:xfrm>
            <a:off x="8910451" y="4347938"/>
            <a:ext cx="1537855" cy="38562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F088C610-DDFA-DE34-8E04-BC67675A9045}"/>
              </a:ext>
            </a:extLst>
          </p:cNvPr>
          <p:cNvSpPr txBox="1"/>
          <p:nvPr/>
        </p:nvSpPr>
        <p:spPr>
          <a:xfrm>
            <a:off x="2944214" y="4218981"/>
            <a:ext cx="22643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FS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months)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89AD35E3-E823-A7D6-9CA8-910422830126}"/>
              </a:ext>
            </a:extLst>
          </p:cNvPr>
          <p:cNvSpPr/>
          <p:nvPr/>
        </p:nvSpPr>
        <p:spPr>
          <a:xfrm>
            <a:off x="4272875" y="526217"/>
            <a:ext cx="1537855" cy="38562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6D94AC39-E9A2-9860-A45B-AFE0F3D9E507}"/>
              </a:ext>
            </a:extLst>
          </p:cNvPr>
          <p:cNvSpPr/>
          <p:nvPr/>
        </p:nvSpPr>
        <p:spPr>
          <a:xfrm>
            <a:off x="3238005" y="4586175"/>
            <a:ext cx="1537855" cy="38562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E71E1236-E0C3-80DA-65FD-5A2834D595A6}"/>
              </a:ext>
            </a:extLst>
          </p:cNvPr>
          <p:cNvSpPr/>
          <p:nvPr/>
        </p:nvSpPr>
        <p:spPr>
          <a:xfrm>
            <a:off x="10003741" y="521010"/>
            <a:ext cx="1668483" cy="73448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78199CC3-6D40-88C5-7D67-D4A0DDAC18C2}"/>
              </a:ext>
            </a:extLst>
          </p:cNvPr>
          <p:cNvSpPr txBox="1"/>
          <p:nvPr/>
        </p:nvSpPr>
        <p:spPr>
          <a:xfrm rot="16200000">
            <a:off x="5650908" y="1376169"/>
            <a:ext cx="22643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ability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FAA11938-9CEA-E0CE-2432-F7C0B6F3D116}"/>
              </a:ext>
            </a:extLst>
          </p:cNvPr>
          <p:cNvSpPr txBox="1"/>
          <p:nvPr/>
        </p:nvSpPr>
        <p:spPr>
          <a:xfrm>
            <a:off x="8892701" y="4261227"/>
            <a:ext cx="22643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months)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56D866D3-7D46-B192-362A-3EF30F7C8986}"/>
              </a:ext>
            </a:extLst>
          </p:cNvPr>
          <p:cNvSpPr/>
          <p:nvPr/>
        </p:nvSpPr>
        <p:spPr>
          <a:xfrm>
            <a:off x="289544" y="4964117"/>
            <a:ext cx="1194621" cy="73448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5EFA1F88-D83B-F7AB-11A5-774C75D76F63}"/>
              </a:ext>
            </a:extLst>
          </p:cNvPr>
          <p:cNvSpPr/>
          <p:nvPr/>
        </p:nvSpPr>
        <p:spPr>
          <a:xfrm>
            <a:off x="406316" y="5086827"/>
            <a:ext cx="1194621" cy="73448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AC790581-6957-9995-2268-4B4A83C2B3D4}"/>
              </a:ext>
            </a:extLst>
          </p:cNvPr>
          <p:cNvSpPr txBox="1"/>
          <p:nvPr/>
        </p:nvSpPr>
        <p:spPr>
          <a:xfrm>
            <a:off x="516168" y="5054206"/>
            <a:ext cx="26444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RTp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ld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ADD954E9-F46E-614A-79DC-1FB351B8E511}"/>
              </a:ext>
            </a:extLst>
          </p:cNvPr>
          <p:cNvSpPr txBox="1"/>
          <p:nvPr/>
        </p:nvSpPr>
        <p:spPr>
          <a:xfrm>
            <a:off x="516652" y="5329362"/>
            <a:ext cx="19323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RTp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t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811577DA-CBBB-4B2D-C0CF-7AFB40CEB514}"/>
              </a:ext>
            </a:extLst>
          </p:cNvPr>
          <p:cNvSpPr/>
          <p:nvPr/>
        </p:nvSpPr>
        <p:spPr>
          <a:xfrm>
            <a:off x="6232485" y="4963846"/>
            <a:ext cx="1194621" cy="73448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B1D863F5-D051-E0B9-82FE-21AB2E257936}"/>
              </a:ext>
            </a:extLst>
          </p:cNvPr>
          <p:cNvSpPr txBox="1"/>
          <p:nvPr/>
        </p:nvSpPr>
        <p:spPr>
          <a:xfrm>
            <a:off x="6459109" y="5053935"/>
            <a:ext cx="26444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RTp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ld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D1C0DBD2-ACEA-CDE3-1FC4-5DE3B43D0C54}"/>
              </a:ext>
            </a:extLst>
          </p:cNvPr>
          <p:cNvSpPr txBox="1"/>
          <p:nvPr/>
        </p:nvSpPr>
        <p:spPr>
          <a:xfrm>
            <a:off x="6459593" y="5329091"/>
            <a:ext cx="19323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RTp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t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257E3C70-B757-13F4-691D-34F9E1005063}"/>
              </a:ext>
            </a:extLst>
          </p:cNvPr>
          <p:cNvSpPr txBox="1"/>
          <p:nvPr/>
        </p:nvSpPr>
        <p:spPr>
          <a:xfrm>
            <a:off x="9007505" y="919022"/>
            <a:ext cx="271054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R: 1.18 (95% CI: 0.77-1.80)</a:t>
            </a:r>
          </a:p>
          <a:p>
            <a:r>
              <a:rPr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p=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49</a:t>
            </a:r>
          </a:p>
        </p:txBody>
      </p:sp>
    </p:spTree>
    <p:extLst>
      <p:ext uri="{BB962C8B-B14F-4D97-AF65-F5344CB8AC3E}">
        <p14:creationId xmlns:p14="http://schemas.microsoft.com/office/powerpoint/2010/main" val="23594361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8</TotalTime>
  <Words>133</Words>
  <Application>Microsoft Macintosh PowerPoint</Application>
  <PresentationFormat>ワイド画面</PresentationFormat>
  <Paragraphs>1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游明朝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比嘉　那優大</dc:creator>
  <cp:lastModifiedBy>那優大 比嘉</cp:lastModifiedBy>
  <cp:revision>10</cp:revision>
  <dcterms:created xsi:type="dcterms:W3CDTF">2023-01-18T09:59:01Z</dcterms:created>
  <dcterms:modified xsi:type="dcterms:W3CDTF">2023-05-30T02:38:54Z</dcterms:modified>
</cp:coreProperties>
</file>